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8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2D0ACD-523D-4975-94DE-6DB0D1FE17D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59148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71600" y="5919840"/>
            <a:ext cx="59148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2FF989-D833-4D84-A2C1-540A9FB77DA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244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71600" y="591984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2440" y="591984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F2086E-06E1-496A-8174-141314511C0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71760" y="263700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71560" y="263700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71600" y="591984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71760" y="591984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71560" y="591984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7BC65A-C046-4257-BCB5-F6FB95313DD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71600" y="2637000"/>
            <a:ext cx="5914800" cy="6284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751"/>
              </a:spcBef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934234-3E21-43A2-9CB7-38185FC94AB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591480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18FF84-2883-487C-945D-961496FA1B9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288612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2440" y="2637000"/>
            <a:ext cx="288612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76661B-FBE2-44EA-A863-D8685C25689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6BAAFD-B3C2-4C33-8ADB-E9CEAAAD60F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71600" y="527040"/>
            <a:ext cx="5914800" cy="8875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751"/>
              </a:spcBef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6D1A8C-7D1D-4DD7-B4E0-C16665CD3E7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2440" y="2637000"/>
            <a:ext cx="288612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71600" y="591984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FE7BF9-8B2D-415D-B8E1-1CE62186D16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288612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244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2440" y="591984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54B425-CBC4-40E9-85D9-1B25748BEE7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244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71600" y="5919840"/>
            <a:ext cx="59148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4D441E-6798-47E5-83C4-47D4E403CC8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71600" y="2637000"/>
            <a:ext cx="591480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1713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1" marL="5144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2" marL="8571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3" marL="12002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4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5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6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71600" y="9182160"/>
            <a:ext cx="154296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9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271600" y="9182160"/>
            <a:ext cx="23148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843440" y="9182160"/>
            <a:ext cx="154296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9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64461D01-7D57-4775-B229-C14177BC1CF5}" type="slidenum">
              <a:rPr b="0" lang="en-US" sz="9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0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1.pn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12.png"/><Relationship Id="rId2" Type="http://schemas.openxmlformats.org/officeDocument/2006/relationships/image" Target="../media/image13.png"/><Relationship Id="rId3" Type="http://schemas.openxmlformats.org/officeDocument/2006/relationships/image" Target="../media/image14.png"/><Relationship Id="rId4" Type="http://schemas.openxmlformats.org/officeDocument/2006/relationships/image" Target="../media/image15.png"/><Relationship Id="rId5" Type="http://schemas.openxmlformats.org/officeDocument/2006/relationships/image" Target="../media/image16.png"/><Relationship Id="rId6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1"/>
          <p:cNvSpPr/>
          <p:nvPr/>
        </p:nvSpPr>
        <p:spPr>
          <a:xfrm>
            <a:off x="-32760" y="-4680"/>
            <a:ext cx="2614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2" name="Picture 2" descr="20170616_Em2_NS_Pax6_488_Ex800ms_Ki67_568_Ex600ms_Pic5_DAPI.png"/>
          <p:cNvPicPr/>
          <p:nvPr/>
        </p:nvPicPr>
        <p:blipFill>
          <a:blip r:embed="rId1"/>
          <a:stretch/>
        </p:blipFill>
        <p:spPr>
          <a:xfrm>
            <a:off x="479520" y="1306440"/>
            <a:ext cx="957240" cy="81432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3" descr="20170616_Em2_NS_Pax6_488_Ex800ms_Ki67_568_Ex600ms_Pic5_Pax6.png"/>
          <p:cNvPicPr/>
          <p:nvPr/>
        </p:nvPicPr>
        <p:blipFill>
          <a:blip r:embed="rId2"/>
          <a:stretch/>
        </p:blipFill>
        <p:spPr>
          <a:xfrm>
            <a:off x="1519200" y="1308240"/>
            <a:ext cx="957240" cy="812520"/>
          </a:xfrm>
          <a:prstGeom prst="rect">
            <a:avLst/>
          </a:prstGeom>
          <a:ln w="0">
            <a:noFill/>
          </a:ln>
        </p:spPr>
      </p:pic>
      <p:pic>
        <p:nvPicPr>
          <p:cNvPr id="44" name="Picture 4" descr="20170616_Em2_NS_Sox2_488_Ex800ms_Ki67_568_Ex600ms_Pic5_Sox2.png"/>
          <p:cNvPicPr/>
          <p:nvPr/>
        </p:nvPicPr>
        <p:blipFill>
          <a:blip r:embed="rId3"/>
          <a:stretch/>
        </p:blipFill>
        <p:spPr>
          <a:xfrm>
            <a:off x="1517760" y="2465280"/>
            <a:ext cx="957240" cy="814320"/>
          </a:xfrm>
          <a:prstGeom prst="rect">
            <a:avLst/>
          </a:prstGeom>
          <a:ln w="0">
            <a:noFill/>
          </a:ln>
        </p:spPr>
      </p:pic>
      <p:pic>
        <p:nvPicPr>
          <p:cNvPr id="45" name="Picture 5" descr="Counter Window - 20170616_Em2_NS_Sox2_488_Ex800ms_Ki67_568_Ex600ms_Pic5_Dapi.png"/>
          <p:cNvPicPr/>
          <p:nvPr/>
        </p:nvPicPr>
        <p:blipFill>
          <a:blip r:embed="rId4"/>
          <a:stretch/>
        </p:blipFill>
        <p:spPr>
          <a:xfrm>
            <a:off x="479520" y="2465280"/>
            <a:ext cx="957240" cy="814320"/>
          </a:xfrm>
          <a:prstGeom prst="rect">
            <a:avLst/>
          </a:prstGeom>
          <a:ln w="0">
            <a:noFill/>
          </a:ln>
        </p:spPr>
      </p:pic>
      <p:pic>
        <p:nvPicPr>
          <p:cNvPr id="46" name="Picture 6" descr="Counter Window - 20170616_Em2_NS_Sox2_488_Ex800ms_Ki67_568_Ex600ms_Pic5_Composite.png"/>
          <p:cNvPicPr/>
          <p:nvPr/>
        </p:nvPicPr>
        <p:blipFill>
          <a:blip r:embed="rId5"/>
          <a:stretch/>
        </p:blipFill>
        <p:spPr>
          <a:xfrm>
            <a:off x="2554200" y="2465280"/>
            <a:ext cx="959040" cy="814320"/>
          </a:xfrm>
          <a:prstGeom prst="rect">
            <a:avLst/>
          </a:prstGeom>
          <a:ln w="0">
            <a:noFill/>
          </a:ln>
        </p:spPr>
      </p:pic>
      <p:pic>
        <p:nvPicPr>
          <p:cNvPr id="47" name="Picture 7" descr="20170616_Em2_NS_Pax6_488_Ex800ms_Ki67_568_Ex600ms_Pic5_Composite.png"/>
          <p:cNvPicPr/>
          <p:nvPr/>
        </p:nvPicPr>
        <p:blipFill>
          <a:blip r:embed="rId6"/>
          <a:stretch/>
        </p:blipFill>
        <p:spPr>
          <a:xfrm>
            <a:off x="2554200" y="1306440"/>
            <a:ext cx="959040" cy="814320"/>
          </a:xfrm>
          <a:prstGeom prst="rect">
            <a:avLst/>
          </a:prstGeom>
          <a:ln w="0">
            <a:noFill/>
          </a:ln>
        </p:spPr>
      </p:pic>
      <p:sp>
        <p:nvSpPr>
          <p:cNvPr id="48" name="Rectangle 8"/>
          <p:cNvSpPr/>
          <p:nvPr/>
        </p:nvSpPr>
        <p:spPr>
          <a:xfrm rot="5400000">
            <a:off x="846720" y="692640"/>
            <a:ext cx="215640" cy="9507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TextBox 9"/>
          <p:cNvSpPr/>
          <p:nvPr/>
        </p:nvSpPr>
        <p:spPr>
          <a:xfrm>
            <a:off x="736200" y="1060560"/>
            <a:ext cx="424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DAPI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Rectangle 10"/>
          <p:cNvSpPr/>
          <p:nvPr/>
        </p:nvSpPr>
        <p:spPr>
          <a:xfrm rot="5400000">
            <a:off x="1883520" y="692640"/>
            <a:ext cx="215640" cy="9511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TextBox 11"/>
          <p:cNvSpPr/>
          <p:nvPr/>
        </p:nvSpPr>
        <p:spPr>
          <a:xfrm>
            <a:off x="1773360" y="1060560"/>
            <a:ext cx="447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PAX6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Rectangle 12"/>
          <p:cNvSpPr/>
          <p:nvPr/>
        </p:nvSpPr>
        <p:spPr>
          <a:xfrm rot="5400000">
            <a:off x="2929680" y="692640"/>
            <a:ext cx="215640" cy="9511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TextBox 13"/>
          <p:cNvSpPr/>
          <p:nvPr/>
        </p:nvSpPr>
        <p:spPr>
          <a:xfrm>
            <a:off x="2755080" y="1060560"/>
            <a:ext cx="554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Overlay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TextBox 20"/>
          <p:cNvSpPr/>
          <p:nvPr/>
        </p:nvSpPr>
        <p:spPr>
          <a:xfrm>
            <a:off x="129600" y="703440"/>
            <a:ext cx="299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TextBox 21"/>
          <p:cNvSpPr/>
          <p:nvPr/>
        </p:nvSpPr>
        <p:spPr>
          <a:xfrm>
            <a:off x="99360" y="675180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6" name="Picture 25" descr=""/>
          <p:cNvPicPr/>
          <p:nvPr/>
        </p:nvPicPr>
        <p:blipFill>
          <a:blip r:embed="rId7"/>
          <a:stretch/>
        </p:blipFill>
        <p:spPr>
          <a:xfrm>
            <a:off x="3513240" y="7085160"/>
            <a:ext cx="2305080" cy="1842840"/>
          </a:xfrm>
          <a:prstGeom prst="rect">
            <a:avLst/>
          </a:prstGeom>
          <a:ln w="0">
            <a:noFill/>
          </a:ln>
        </p:spPr>
      </p:pic>
      <p:sp>
        <p:nvSpPr>
          <p:cNvPr id="57" name="TextBox 26"/>
          <p:cNvSpPr/>
          <p:nvPr/>
        </p:nvSpPr>
        <p:spPr>
          <a:xfrm>
            <a:off x="129600" y="3759120"/>
            <a:ext cx="299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TextBox 32"/>
          <p:cNvSpPr/>
          <p:nvPr/>
        </p:nvSpPr>
        <p:spPr>
          <a:xfrm>
            <a:off x="3160080" y="684216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D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9" name="Picture 36" descr=""/>
          <p:cNvPicPr/>
          <p:nvPr/>
        </p:nvPicPr>
        <p:blipFill>
          <a:blip r:embed="rId8"/>
          <a:stretch/>
        </p:blipFill>
        <p:spPr>
          <a:xfrm>
            <a:off x="279360" y="7095960"/>
            <a:ext cx="2751120" cy="1832040"/>
          </a:xfrm>
          <a:prstGeom prst="rect">
            <a:avLst/>
          </a:prstGeom>
          <a:ln w="0">
            <a:noFill/>
          </a:ln>
        </p:spPr>
      </p:pic>
      <p:sp>
        <p:nvSpPr>
          <p:cNvPr id="60" name="Rectangle 37"/>
          <p:cNvSpPr/>
          <p:nvPr/>
        </p:nvSpPr>
        <p:spPr>
          <a:xfrm rot="5400000">
            <a:off x="846360" y="1856520"/>
            <a:ext cx="216000" cy="9507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TextBox 38"/>
          <p:cNvSpPr/>
          <p:nvPr/>
        </p:nvSpPr>
        <p:spPr>
          <a:xfrm>
            <a:off x="736200" y="2224080"/>
            <a:ext cx="424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DAPI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Rectangle 39"/>
          <p:cNvSpPr/>
          <p:nvPr/>
        </p:nvSpPr>
        <p:spPr>
          <a:xfrm rot="5400000">
            <a:off x="1883520" y="1856520"/>
            <a:ext cx="216000" cy="9511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TextBox 40"/>
          <p:cNvSpPr/>
          <p:nvPr/>
        </p:nvSpPr>
        <p:spPr>
          <a:xfrm>
            <a:off x="1773360" y="2224080"/>
            <a:ext cx="453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SOX2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Rectangle 41"/>
          <p:cNvSpPr/>
          <p:nvPr/>
        </p:nvSpPr>
        <p:spPr>
          <a:xfrm rot="5400000">
            <a:off x="2929680" y="1856520"/>
            <a:ext cx="216000" cy="9511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TextBox 42"/>
          <p:cNvSpPr/>
          <p:nvPr/>
        </p:nvSpPr>
        <p:spPr>
          <a:xfrm>
            <a:off x="2755080" y="2224080"/>
            <a:ext cx="554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Overlay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6" name="Picture 44" descr=""/>
          <p:cNvPicPr/>
          <p:nvPr/>
        </p:nvPicPr>
        <p:blipFill>
          <a:blip r:embed="rId9"/>
          <a:stretch/>
        </p:blipFill>
        <p:spPr>
          <a:xfrm>
            <a:off x="254160" y="3978360"/>
            <a:ext cx="4222440" cy="21114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TextBox 1"/>
          <p:cNvSpPr/>
          <p:nvPr/>
        </p:nvSpPr>
        <p:spPr>
          <a:xfrm>
            <a:off x="-32760" y="-4680"/>
            <a:ext cx="2614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2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8" name="Picture 4" descr=""/>
          <p:cNvPicPr/>
          <p:nvPr/>
        </p:nvPicPr>
        <p:blipFill>
          <a:blip r:embed="rId1"/>
          <a:stretch/>
        </p:blipFill>
        <p:spPr>
          <a:xfrm>
            <a:off x="530280" y="822240"/>
            <a:ext cx="1989000" cy="1590840"/>
          </a:xfrm>
          <a:prstGeom prst="rect">
            <a:avLst/>
          </a:prstGeom>
          <a:ln w="0">
            <a:noFill/>
          </a:ln>
        </p:spPr>
      </p:pic>
      <p:sp>
        <p:nvSpPr>
          <p:cNvPr id="69" name="TextBox 6"/>
          <p:cNvSpPr/>
          <p:nvPr/>
        </p:nvSpPr>
        <p:spPr>
          <a:xfrm>
            <a:off x="227880" y="514440"/>
            <a:ext cx="299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Right Bracket 12"/>
          <p:cNvSpPr/>
          <p:nvPr/>
        </p:nvSpPr>
        <p:spPr>
          <a:xfrm rot="16200000">
            <a:off x="1680480" y="651240"/>
            <a:ext cx="50760" cy="716040"/>
          </a:xfrm>
          <a:custGeom>
            <a:avLst/>
            <a:gdLst>
              <a:gd name="textAreaLeft" fmla="*/ 0 w 50760"/>
              <a:gd name="textAreaRight" fmla="*/ 35640 w 50760"/>
              <a:gd name="textAreaTop" fmla="*/ 1800 h 716040"/>
              <a:gd name="textAreaBottom" fmla="*/ 714240 h 7160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10800" y="0"/>
                  <a:pt x="21600" y="64"/>
                  <a:pt x="21600" y="127"/>
                </a:cubicBezTo>
                <a:lnTo>
                  <a:pt x="21600" y="21473"/>
                </a:lnTo>
                <a:cubicBezTo>
                  <a:pt x="21600" y="21537"/>
                  <a:pt x="10800" y="21600"/>
                  <a:pt x="0" y="21600"/>
                </a:cubicBezTo>
              </a:path>
            </a:pathLst>
          </a:cu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TextBox 13"/>
          <p:cNvSpPr/>
          <p:nvPr/>
        </p:nvSpPr>
        <p:spPr>
          <a:xfrm>
            <a:off x="1568160" y="822240"/>
            <a:ext cx="273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ns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TextBox 1"/>
          <p:cNvSpPr/>
          <p:nvPr/>
        </p:nvSpPr>
        <p:spPr>
          <a:xfrm>
            <a:off x="-32760" y="-4680"/>
            <a:ext cx="2614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3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TextBox 3"/>
          <p:cNvSpPr/>
          <p:nvPr/>
        </p:nvSpPr>
        <p:spPr>
          <a:xfrm>
            <a:off x="161280" y="706320"/>
            <a:ext cx="299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4" name="Picture 5" descr=""/>
          <p:cNvPicPr/>
          <p:nvPr/>
        </p:nvPicPr>
        <p:blipFill>
          <a:blip r:embed="rId1"/>
          <a:stretch/>
        </p:blipFill>
        <p:spPr>
          <a:xfrm>
            <a:off x="463680" y="1014480"/>
            <a:ext cx="6040440" cy="41558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5" name="Picture 20" descr=""/>
          <p:cNvPicPr/>
          <p:nvPr/>
        </p:nvPicPr>
        <p:blipFill>
          <a:blip r:embed="rId1"/>
          <a:stretch/>
        </p:blipFill>
        <p:spPr>
          <a:xfrm>
            <a:off x="463680" y="1212840"/>
            <a:ext cx="5524200" cy="2762280"/>
          </a:xfrm>
          <a:prstGeom prst="rect">
            <a:avLst/>
          </a:prstGeom>
          <a:ln w="0">
            <a:noFill/>
          </a:ln>
        </p:spPr>
      </p:pic>
      <p:sp>
        <p:nvSpPr>
          <p:cNvPr id="76" name="TextBox 9"/>
          <p:cNvSpPr/>
          <p:nvPr/>
        </p:nvSpPr>
        <p:spPr>
          <a:xfrm>
            <a:off x="-32760" y="-4680"/>
            <a:ext cx="2614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4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TextBox 14"/>
          <p:cNvSpPr/>
          <p:nvPr/>
        </p:nvSpPr>
        <p:spPr>
          <a:xfrm>
            <a:off x="387360" y="4278240"/>
            <a:ext cx="299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TextBox 25"/>
          <p:cNvSpPr/>
          <p:nvPr/>
        </p:nvSpPr>
        <p:spPr>
          <a:xfrm>
            <a:off x="299520" y="694224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TextBox 32"/>
          <p:cNvSpPr/>
          <p:nvPr/>
        </p:nvSpPr>
        <p:spPr>
          <a:xfrm>
            <a:off x="377280" y="1008000"/>
            <a:ext cx="299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TextBox 34"/>
          <p:cNvSpPr/>
          <p:nvPr/>
        </p:nvSpPr>
        <p:spPr>
          <a:xfrm>
            <a:off x="874440" y="1535040"/>
            <a:ext cx="613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Cor=0.9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TextBox 35"/>
          <p:cNvSpPr/>
          <p:nvPr/>
        </p:nvSpPr>
        <p:spPr>
          <a:xfrm>
            <a:off x="2498400" y="1535040"/>
            <a:ext cx="613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Cor=0.76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TextBox 36"/>
          <p:cNvSpPr/>
          <p:nvPr/>
        </p:nvSpPr>
        <p:spPr>
          <a:xfrm>
            <a:off x="4146120" y="1535040"/>
            <a:ext cx="613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Cor=0.86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TextBox 37"/>
          <p:cNvSpPr/>
          <p:nvPr/>
        </p:nvSpPr>
        <p:spPr>
          <a:xfrm>
            <a:off x="874440" y="2759040"/>
            <a:ext cx="613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Cor=0.92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TextBox 38"/>
          <p:cNvSpPr/>
          <p:nvPr/>
        </p:nvSpPr>
        <p:spPr>
          <a:xfrm>
            <a:off x="2498400" y="2759040"/>
            <a:ext cx="613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Cor=0.98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TextBox 39"/>
          <p:cNvSpPr/>
          <p:nvPr/>
        </p:nvSpPr>
        <p:spPr>
          <a:xfrm>
            <a:off x="4146120" y="2759040"/>
            <a:ext cx="613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Cor=0.83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86" name="Picture 6" descr=""/>
          <p:cNvPicPr/>
          <p:nvPr/>
        </p:nvPicPr>
        <p:blipFill>
          <a:blip r:embed="rId2"/>
          <a:stretch/>
        </p:blipFill>
        <p:spPr>
          <a:xfrm>
            <a:off x="2055960" y="4729320"/>
            <a:ext cx="2617560" cy="2181240"/>
          </a:xfrm>
          <a:prstGeom prst="rect">
            <a:avLst/>
          </a:prstGeom>
          <a:ln w="0">
            <a:noFill/>
          </a:ln>
        </p:spPr>
      </p:pic>
      <p:pic>
        <p:nvPicPr>
          <p:cNvPr id="87" name="Picture 16" descr=""/>
          <p:cNvPicPr/>
          <p:nvPr/>
        </p:nvPicPr>
        <p:blipFill>
          <a:blip r:embed="rId3"/>
          <a:stretch/>
        </p:blipFill>
        <p:spPr>
          <a:xfrm>
            <a:off x="693720" y="4610160"/>
            <a:ext cx="1162080" cy="2325600"/>
          </a:xfrm>
          <a:prstGeom prst="rect">
            <a:avLst/>
          </a:prstGeom>
          <a:ln w="0">
            <a:noFill/>
          </a:ln>
        </p:spPr>
      </p:pic>
      <p:pic>
        <p:nvPicPr>
          <p:cNvPr id="88" name="Picture 18" descr=""/>
          <p:cNvPicPr/>
          <p:nvPr/>
        </p:nvPicPr>
        <p:blipFill>
          <a:blip r:embed="rId4"/>
          <a:stretch/>
        </p:blipFill>
        <p:spPr>
          <a:xfrm>
            <a:off x="2055960" y="7232760"/>
            <a:ext cx="2617560" cy="2181240"/>
          </a:xfrm>
          <a:prstGeom prst="rect">
            <a:avLst/>
          </a:prstGeom>
          <a:ln w="0">
            <a:noFill/>
          </a:ln>
        </p:spPr>
      </p:pic>
      <p:pic>
        <p:nvPicPr>
          <p:cNvPr id="89" name="Picture 23" descr=""/>
          <p:cNvPicPr/>
          <p:nvPr/>
        </p:nvPicPr>
        <p:blipFill>
          <a:blip r:embed="rId5"/>
          <a:stretch/>
        </p:blipFill>
        <p:spPr>
          <a:xfrm>
            <a:off x="693720" y="7129440"/>
            <a:ext cx="1162080" cy="23256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" name="TextBox 1"/>
          <p:cNvSpPr/>
          <p:nvPr/>
        </p:nvSpPr>
        <p:spPr>
          <a:xfrm>
            <a:off x="-47880" y="-4680"/>
            <a:ext cx="2538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Supplementary Table 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91" name=""/>
          <p:cNvGraphicFramePr/>
          <p:nvPr/>
        </p:nvGraphicFramePr>
        <p:xfrm>
          <a:off x="942840" y="1190520"/>
          <a:ext cx="4918320" cy="2357640"/>
        </p:xfrm>
        <a:graphic>
          <a:graphicData uri="http://schemas.openxmlformats.org/drawingml/2006/table">
            <a:tbl>
              <a:tblPr/>
              <a:tblGrid>
                <a:gridCol w="1121040"/>
                <a:gridCol w="1846080"/>
                <a:gridCol w="1951200"/>
              </a:tblGrid>
              <a:tr h="50328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3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ene name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3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rimer 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3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equence FW (5’   3’)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3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rimer 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3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equence RV (5’   3’)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7152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i="1" lang="en-US" sz="13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Id1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cgagatcagtgccttg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tcctgaagggctggagtc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700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i="1" lang="en-US" sz="13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Id2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acagaaccaggcgtcc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gctcagaagggaattcagat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7116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i="1" lang="en-US" sz="13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Id3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aggagcttttgccactgac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ctcatccatgccctca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700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i="1" lang="en-US" sz="13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Id4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ctcgtgcctaccatcccgc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gtggcggctgtctcagca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7152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i="1" lang="en-US" sz="13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APDH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tgcagtgccagcctcgtcc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ccactgcaaatggcagccc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cxnSp>
        <p:nvCxnSpPr>
          <p:cNvPr id="92" name="Straight Arrow Connector 4"/>
          <p:cNvCxnSpPr/>
          <p:nvPr/>
        </p:nvCxnSpPr>
        <p:spPr>
          <a:xfrm>
            <a:off x="3465360" y="1560240"/>
            <a:ext cx="115200" cy="108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93" name="Straight Arrow Connector 5"/>
          <p:cNvCxnSpPr/>
          <p:nvPr/>
        </p:nvCxnSpPr>
        <p:spPr>
          <a:xfrm>
            <a:off x="5351040" y="1550520"/>
            <a:ext cx="113400" cy="108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arrow" w="med"/>
          </a:ln>
        </p:spPr>
      </p:cxn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84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0-12-11T14:22:39Z</dcterms:created>
  <dc:creator>Elli Marinopoulou</dc:creator>
  <dc:description/>
  <dc:language>en-US</dc:language>
  <cp:lastModifiedBy>Elli Marinopoulou</cp:lastModifiedBy>
  <dcterms:modified xsi:type="dcterms:W3CDTF">2021-02-17T17:33:51Z</dcterms:modified>
  <cp:revision>146</cp:revision>
  <dc:subject/>
  <dc:title>PowerPoint Presentation</dc:title>
</cp:coreProperties>
</file>